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9456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25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63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271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0220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643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90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2131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0543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7328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441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0268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776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5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58398" y="260648"/>
            <a:ext cx="9073747" cy="5088180"/>
            <a:chOff x="58398" y="260648"/>
            <a:chExt cx="9073747" cy="5088180"/>
          </a:xfrm>
        </p:grpSpPr>
        <p:grpSp>
          <p:nvGrpSpPr>
            <p:cNvPr id="2" name="그룹 1"/>
            <p:cNvGrpSpPr/>
            <p:nvPr/>
          </p:nvGrpSpPr>
          <p:grpSpPr>
            <a:xfrm>
              <a:off x="58398" y="260648"/>
              <a:ext cx="9073747" cy="5088180"/>
              <a:chOff x="58398" y="260648"/>
              <a:chExt cx="9073747" cy="5088180"/>
            </a:xfrm>
          </p:grpSpPr>
          <p:pic>
            <p:nvPicPr>
              <p:cNvPr id="1026" name="Picture 2" descr="C:\Users\Chang-Hee Kim\Documents\김창희\Works\Study\Writing\Writing\Writing\2020 MD with DCPN_노해민\연구데이터\채현기 Lt MD 20130416 PTA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6109" y="556812"/>
                <a:ext cx="4791847" cy="223399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7" name="Picture 3" descr="C:\Users\Chang-Hee Kim\Documents\김창희\Works\Study\Writing\Writing\Writing\2020 MD with DCPN_노해민\연구데이터\채현기 1st caloric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86693" y="652344"/>
                <a:ext cx="4045452" cy="20384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9" name="Picture 5" descr="C:\Users\Chang-Hee Kim\Documents\김창희\Works\Study\Writing\Writing\Writing\2020 MD with DCPN_노해민\연구데이터\채현기 2nd Rt HR.jpg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5107" y="3053548"/>
                <a:ext cx="3919290" cy="21036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 descr="C:\Users\Chang-Hee Kim\Documents\김창희\Works\Study\Writing\Writing\Writing\2020 MD with DCPN_노해민\연구데이터\채현기 2nd Lt HR.jp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826816" y="3053548"/>
                <a:ext cx="3993656" cy="21036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58398" y="260648"/>
                <a:ext cx="3561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922515" y="260648"/>
                <a:ext cx="34018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37270" y="2852936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532851" y="2852936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00812" y="541600"/>
                <a:ext cx="3577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B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726425" y="495722"/>
                <a:ext cx="3577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B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-100181" y="3978289"/>
                <a:ext cx="9204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ye position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4291288" y="3978289"/>
                <a:ext cx="9204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ye position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748824" y="5094912"/>
                <a:ext cx="4395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75744" y="5094912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8149360" y="5065728"/>
                <a:ext cx="4395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037368" y="5065728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966608" y="518483"/>
              <a:ext cx="99418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Ear - H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15334" y="461814"/>
              <a:ext cx="90762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Ear - H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475289" y="817662"/>
              <a:ext cx="1472975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Cool Peak SPV: 39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438555" y="817662"/>
              <a:ext cx="1472975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Warm Peak SPV: 12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437189" y="2207220"/>
              <a:ext cx="1544983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Warm Peak SPV: -20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419505" y="2211308"/>
              <a:ext cx="1472975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Cool Peak SPV: -38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8028384" y="2525663"/>
              <a:ext cx="340748" cy="961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6074643" y="2530996"/>
              <a:ext cx="340748" cy="961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903418" y="2478038"/>
              <a:ext cx="5749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cond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955010" y="2473846"/>
              <a:ext cx="5749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cond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5186464" y="836712"/>
              <a:ext cx="65149" cy="1584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7154663" y="912112"/>
              <a:ext cx="65149" cy="1584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801451" y="1467165"/>
              <a:ext cx="840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V, deg/s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6780154" y="1466024"/>
              <a:ext cx="840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V, deg/s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2377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62</Words>
  <Application>Microsoft Office PowerPoint</Application>
  <PresentationFormat>화면 슬라이드 쇼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Windows User</cp:lastModifiedBy>
  <cp:revision>5</cp:revision>
  <cp:lastPrinted>2020-12-09T07:13:09Z</cp:lastPrinted>
  <dcterms:created xsi:type="dcterms:W3CDTF">2020-12-09T06:50:09Z</dcterms:created>
  <dcterms:modified xsi:type="dcterms:W3CDTF">2021-01-25T06:44:51Z</dcterms:modified>
</cp:coreProperties>
</file>